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110"/>
    <p:restoredTop sz="94694"/>
  </p:normalViewPr>
  <p:slideViewPr>
    <p:cSldViewPr snapToGrid="0">
      <p:cViewPr varScale="1">
        <p:scale>
          <a:sx n="68" d="100"/>
          <a:sy n="68" d="100"/>
        </p:scale>
        <p:origin x="3976" y="2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6B7A6-AF1C-794E-BCEF-5EA633E793BC}" type="datetimeFigureOut">
              <a:rPr lang="en-US" smtClean="0"/>
              <a:t>11/1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D01F7-12A5-654A-8841-D08D0062E3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64828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6B7A6-AF1C-794E-BCEF-5EA633E793BC}" type="datetimeFigureOut">
              <a:rPr lang="en-US" smtClean="0"/>
              <a:t>11/1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D01F7-12A5-654A-8841-D08D0062E3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9136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6B7A6-AF1C-794E-BCEF-5EA633E793BC}" type="datetimeFigureOut">
              <a:rPr lang="en-US" smtClean="0"/>
              <a:t>11/1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D01F7-12A5-654A-8841-D08D0062E3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1093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6B7A6-AF1C-794E-BCEF-5EA633E793BC}" type="datetimeFigureOut">
              <a:rPr lang="en-US" smtClean="0"/>
              <a:t>11/1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D01F7-12A5-654A-8841-D08D0062E3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77083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6B7A6-AF1C-794E-BCEF-5EA633E793BC}" type="datetimeFigureOut">
              <a:rPr lang="en-US" smtClean="0"/>
              <a:t>11/1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D01F7-12A5-654A-8841-D08D0062E3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04904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6B7A6-AF1C-794E-BCEF-5EA633E793BC}" type="datetimeFigureOut">
              <a:rPr lang="en-US" smtClean="0"/>
              <a:t>11/14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D01F7-12A5-654A-8841-D08D0062E3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76002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6B7A6-AF1C-794E-BCEF-5EA633E793BC}" type="datetimeFigureOut">
              <a:rPr lang="en-US" smtClean="0"/>
              <a:t>11/14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D01F7-12A5-654A-8841-D08D0062E3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34468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6B7A6-AF1C-794E-BCEF-5EA633E793BC}" type="datetimeFigureOut">
              <a:rPr lang="en-US" smtClean="0"/>
              <a:t>11/14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D01F7-12A5-654A-8841-D08D0062E3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44441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6B7A6-AF1C-794E-BCEF-5EA633E793BC}" type="datetimeFigureOut">
              <a:rPr lang="en-US" smtClean="0"/>
              <a:t>11/14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D01F7-12A5-654A-8841-D08D0062E3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22089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6B7A6-AF1C-794E-BCEF-5EA633E793BC}" type="datetimeFigureOut">
              <a:rPr lang="en-US" smtClean="0"/>
              <a:t>11/14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D01F7-12A5-654A-8841-D08D0062E3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37056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6B7A6-AF1C-794E-BCEF-5EA633E793BC}" type="datetimeFigureOut">
              <a:rPr lang="en-US" smtClean="0"/>
              <a:t>11/14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D01F7-12A5-654A-8841-D08D0062E3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53620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226B7A6-AF1C-794E-BCEF-5EA633E793BC}" type="datetimeFigureOut">
              <a:rPr lang="en-US" smtClean="0"/>
              <a:t>11/1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AED01F7-12A5-654A-8841-D08D0062E3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24860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D53F1D3D-C9E5-4C5D-5112-4A3067E842F4}"/>
              </a:ext>
            </a:extLst>
          </p:cNvPr>
          <p:cNvSpPr txBox="1"/>
          <p:nvPr/>
        </p:nvSpPr>
        <p:spPr>
          <a:xfrm>
            <a:off x="788221" y="9921303"/>
            <a:ext cx="553257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Alignment of IS5 at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mR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Sequence 1) with wildtype IS5 (Sequence 2). 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tched nucleotides between two sequences are marked by stars while unmatched ones are not marked. There is a 91.5% identity between the two IS5 elements.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495DE9CF-51D8-B31B-F542-6CC513DCE3B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34231" b="3184"/>
          <a:stretch/>
        </p:blipFill>
        <p:spPr>
          <a:xfrm>
            <a:off x="880110" y="857807"/>
            <a:ext cx="5177790" cy="90634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206440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</TotalTime>
  <Words>47</Words>
  <Application>Microsoft Macintosh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ongge Zhang</dc:creator>
  <cp:lastModifiedBy>Huo, Jialu</cp:lastModifiedBy>
  <cp:revision>5</cp:revision>
  <dcterms:created xsi:type="dcterms:W3CDTF">2024-10-18T21:09:23Z</dcterms:created>
  <dcterms:modified xsi:type="dcterms:W3CDTF">2024-11-14T23:22:21Z</dcterms:modified>
</cp:coreProperties>
</file>